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media/image12.jpg" ContentType="image/tiff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88" r:id="rId2"/>
    <p:sldId id="289" r:id="rId3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02"/>
    <p:restoredTop sz="94558"/>
  </p:normalViewPr>
  <p:slideViewPr>
    <p:cSldViewPr snapToGrid="0">
      <p:cViewPr varScale="1">
        <p:scale>
          <a:sx n="77" d="100"/>
          <a:sy n="77" d="100"/>
        </p:scale>
        <p:origin x="376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otou\Documents\R-Spondin%203\RSPO3KO_CTX\250111_230924_WB_PIDay15\250110_&#12454;&#12456;&#12473;&#12479;&#12531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otou\Documents\R-Spondin%203\RSPO3KO_CTX\250111_230924_WB_PIDay15\250110_&#12454;&#12456;&#12473;&#12479;&#12531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otou\Documents\R-Spondin%203\RSPO3KO_CTX\250111_230924_WB_PIDay15\250110_&#12454;&#12456;&#12473;&#12479;&#12531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otou\Documents\R-Spondin%203\RSPO3KO_CTX\250111_230924_WB_PIDay15\250110_&#12454;&#12456;&#12473;&#12479;&#12531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otou\Documents\R-Spondin%203\RSPO3KO_CTX\250111_230924_WB_PIDay15\250110_&#12454;&#12456;&#12473;&#12479;&#12531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otou\Documents\R-Spondin%203\RSPO3KO_CTX\250111_230924_WB_PIDay15\250110_&#12454;&#12456;&#12473;&#12479;&#12531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otou/Documents/R-Spondin%203/RSPO3KO_CTX/250411_CTX/250411_CTX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otou/Documents/R-Spondin%203/RSPO3KO_CTX/250411_CTX/250411_CTX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otou/Documents/R-Spondin%203/RSPO3KO_CTX/250411_CTX/250411_CTX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E4C-CA44-B226-F16223B64C6F}"/>
              </c:ext>
            </c:extLst>
          </c:dPt>
          <c:errBars>
            <c:errBarType val="both"/>
            <c:errValType val="cust"/>
            <c:noEndCap val="0"/>
            <c:plus>
              <c:numRef>
                <c:f>'250110Result'!$X$21:$Y$21</c:f>
                <c:numCache>
                  <c:formatCode>General</c:formatCode>
                  <c:ptCount val="2"/>
                  <c:pt idx="0">
                    <c:v>0.15838605715283174</c:v>
                  </c:pt>
                  <c:pt idx="1">
                    <c:v>0.24582812859689632</c:v>
                  </c:pt>
                </c:numCache>
              </c:numRef>
            </c:plus>
            <c:minus>
              <c:numRef>
                <c:f>'250110Result'!$X$21:$Y$21</c:f>
                <c:numCache>
                  <c:formatCode>General</c:formatCode>
                  <c:ptCount val="2"/>
                  <c:pt idx="0">
                    <c:v>0.15838605715283174</c:v>
                  </c:pt>
                  <c:pt idx="1">
                    <c:v>0.2458281285968963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50110Result'!$X$3:$Y$3</c:f>
              <c:strCache>
                <c:ptCount val="2"/>
                <c:pt idx="0">
                  <c:v>WT</c:v>
                </c:pt>
                <c:pt idx="1">
                  <c:v>Rspo3 mKO</c:v>
                </c:pt>
              </c:strCache>
            </c:strRef>
          </c:cat>
          <c:val>
            <c:numRef>
              <c:f>'250110Result'!$X$20:$Y$20</c:f>
              <c:numCache>
                <c:formatCode>0.000</c:formatCode>
                <c:ptCount val="2"/>
                <c:pt idx="0">
                  <c:v>1</c:v>
                </c:pt>
                <c:pt idx="1">
                  <c:v>1.06310374614892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E4C-CA44-B226-F16223B64C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73156160"/>
        <c:axId val="1072859888"/>
      </c:barChart>
      <c:catAx>
        <c:axId val="1073156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2859888"/>
        <c:crosses val="autoZero"/>
        <c:auto val="1"/>
        <c:lblAlgn val="ctr"/>
        <c:lblOffset val="100"/>
        <c:noMultiLvlLbl val="0"/>
      </c:catAx>
      <c:valAx>
        <c:axId val="1072859888"/>
        <c:scaling>
          <c:orientation val="minMax"/>
          <c:max val="1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MyHC I/GAPDH</a:t>
                </a:r>
              </a:p>
              <a:p>
                <a:pPr>
                  <a:defRPr lang="ja-JP"/>
                </a:pPr>
                <a:r>
                  <a:rPr lang="en-US" dirty="0"/>
                  <a:t>(Relati</a:t>
                </a:r>
                <a:r>
                  <a:rPr lang="en-US" sz="800" b="0" i="0" u="none" strike="noStrike" kern="1200" baseline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r>
                  <a:rPr lang="en-US" dirty="0"/>
                  <a:t>e 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JP"/>
            </a:p>
          </c:txPr>
        </c:title>
        <c:numFmt formatCode="0.0;\-0.0;0;@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31561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DF2-474D-9D10-96E8FAA29865}"/>
              </c:ext>
            </c:extLst>
          </c:dPt>
          <c:errBars>
            <c:errBarType val="both"/>
            <c:errValType val="cust"/>
            <c:noEndCap val="0"/>
            <c:plus>
              <c:numRef>
                <c:f>'250110Result'!$X$47:$Y$47</c:f>
                <c:numCache>
                  <c:formatCode>General</c:formatCode>
                  <c:ptCount val="2"/>
                  <c:pt idx="0">
                    <c:v>7.5568070795796291E-2</c:v>
                  </c:pt>
                  <c:pt idx="1">
                    <c:v>0.13294262033583007</c:v>
                  </c:pt>
                </c:numCache>
              </c:numRef>
            </c:plus>
            <c:minus>
              <c:numRef>
                <c:f>'250110Result'!$X$47:$Y$47</c:f>
                <c:numCache>
                  <c:formatCode>General</c:formatCode>
                  <c:ptCount val="2"/>
                  <c:pt idx="0">
                    <c:v>7.5568070795796291E-2</c:v>
                  </c:pt>
                  <c:pt idx="1">
                    <c:v>0.13294262033583007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50110Result'!$X$3:$Y$3</c:f>
              <c:strCache>
                <c:ptCount val="2"/>
                <c:pt idx="0">
                  <c:v>WT</c:v>
                </c:pt>
                <c:pt idx="1">
                  <c:v>Rspo3 mKO</c:v>
                </c:pt>
              </c:strCache>
            </c:strRef>
          </c:cat>
          <c:val>
            <c:numRef>
              <c:f>'250110Result'!$X$46:$Y$46</c:f>
              <c:numCache>
                <c:formatCode>0.000</c:formatCode>
                <c:ptCount val="2"/>
                <c:pt idx="0">
                  <c:v>1</c:v>
                </c:pt>
                <c:pt idx="1">
                  <c:v>1.01023655309087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DF2-474D-9D10-96E8FAA298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73156160"/>
        <c:axId val="1072859888"/>
      </c:barChart>
      <c:catAx>
        <c:axId val="1073156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2859888"/>
        <c:crosses val="autoZero"/>
        <c:auto val="1"/>
        <c:lblAlgn val="ctr"/>
        <c:lblOffset val="100"/>
        <c:noMultiLvlLbl val="0"/>
      </c:catAx>
      <c:valAx>
        <c:axId val="1072859888"/>
        <c:scaling>
          <c:orientation val="minMax"/>
          <c:max val="1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MyHC II/GAPDH</a:t>
                </a:r>
              </a:p>
              <a:p>
                <a:pPr>
                  <a:defRPr lang="ja-JP"/>
                </a:pPr>
                <a:r>
                  <a:rPr lang="en-US" dirty="0"/>
                  <a:t>(Relati</a:t>
                </a:r>
                <a:r>
                  <a:rPr lang="en-US" sz="800" b="0" i="0" u="none" strike="noStrike" kern="1200" baseline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r>
                  <a:rPr lang="en-US" dirty="0"/>
                  <a:t>e 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JP"/>
            </a:p>
          </c:txPr>
        </c:title>
        <c:numFmt formatCode="0.0;\-0.0;0;@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31561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CBD-F743-9428-9F219722DCD1}"/>
              </c:ext>
            </c:extLst>
          </c:dPt>
          <c:errBars>
            <c:errBarType val="both"/>
            <c:errValType val="cust"/>
            <c:noEndCap val="0"/>
            <c:plus>
              <c:numRef>
                <c:f>'250110Result'!$X$74:$Y$74</c:f>
                <c:numCache>
                  <c:formatCode>General</c:formatCode>
                  <c:ptCount val="2"/>
                  <c:pt idx="0">
                    <c:v>3.1576031616074807E-2</c:v>
                  </c:pt>
                  <c:pt idx="1">
                    <c:v>9.470979631792649E-2</c:v>
                  </c:pt>
                </c:numCache>
              </c:numRef>
            </c:plus>
            <c:minus>
              <c:numRef>
                <c:f>'250110Result'!$X$74:$Y$74</c:f>
                <c:numCache>
                  <c:formatCode>General</c:formatCode>
                  <c:ptCount val="2"/>
                  <c:pt idx="0">
                    <c:v>3.1576031616074807E-2</c:v>
                  </c:pt>
                  <c:pt idx="1">
                    <c:v>9.470979631792649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50110Result'!$X$3:$Y$3</c:f>
              <c:strCache>
                <c:ptCount val="2"/>
                <c:pt idx="0">
                  <c:v>WT</c:v>
                </c:pt>
                <c:pt idx="1">
                  <c:v>Rspo3 mKO</c:v>
                </c:pt>
              </c:strCache>
            </c:strRef>
          </c:cat>
          <c:val>
            <c:numRef>
              <c:f>'250110Result'!$X$73:$Y$73</c:f>
              <c:numCache>
                <c:formatCode>0.000</c:formatCode>
                <c:ptCount val="2"/>
                <c:pt idx="0">
                  <c:v>1</c:v>
                </c:pt>
                <c:pt idx="1">
                  <c:v>1.02986657037905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CBD-F743-9428-9F219722DC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73156160"/>
        <c:axId val="1072859888"/>
      </c:barChart>
      <c:catAx>
        <c:axId val="1073156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2859888"/>
        <c:crosses val="autoZero"/>
        <c:auto val="1"/>
        <c:lblAlgn val="ctr"/>
        <c:lblOffset val="100"/>
        <c:noMultiLvlLbl val="0"/>
      </c:catAx>
      <c:valAx>
        <c:axId val="1072859888"/>
        <c:scaling>
          <c:orientation val="minMax"/>
          <c:max val="1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PGC1</a:t>
                </a:r>
                <a:r>
                  <a:rPr lang="el-GR" dirty="0"/>
                  <a:t>α</a:t>
                </a:r>
                <a:r>
                  <a:rPr lang="en-US" dirty="0"/>
                  <a:t>/GAPDH</a:t>
                </a:r>
              </a:p>
              <a:p>
                <a:pPr>
                  <a:defRPr lang="ja-JP"/>
                </a:pPr>
                <a:r>
                  <a:rPr lang="en-US" dirty="0"/>
                  <a:t>(Relative 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JP"/>
            </a:p>
          </c:txPr>
        </c:title>
        <c:numFmt formatCode="0.0;\-0.0;0;@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31561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DA1-314D-8703-7371D734D0C8}"/>
              </c:ext>
            </c:extLst>
          </c:dPt>
          <c:errBars>
            <c:errBarType val="both"/>
            <c:errValType val="cust"/>
            <c:noEndCap val="0"/>
            <c:plus>
              <c:numRef>
                <c:f>'250110Result'!$X$100:$Y$100</c:f>
                <c:numCache>
                  <c:formatCode>General</c:formatCode>
                  <c:ptCount val="2"/>
                  <c:pt idx="0">
                    <c:v>9.1535032500606309E-2</c:v>
                  </c:pt>
                  <c:pt idx="1">
                    <c:v>8.06846305285603E-2</c:v>
                  </c:pt>
                </c:numCache>
              </c:numRef>
            </c:plus>
            <c:minus>
              <c:numRef>
                <c:f>'250110Result'!$X$100:$Y$100</c:f>
                <c:numCache>
                  <c:formatCode>General</c:formatCode>
                  <c:ptCount val="2"/>
                  <c:pt idx="0">
                    <c:v>9.1535032500606309E-2</c:v>
                  </c:pt>
                  <c:pt idx="1">
                    <c:v>8.06846305285603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50110Result'!$X$3:$Y$3</c:f>
              <c:strCache>
                <c:ptCount val="2"/>
                <c:pt idx="0">
                  <c:v>WT</c:v>
                </c:pt>
                <c:pt idx="1">
                  <c:v>Rspo3 mKO</c:v>
                </c:pt>
              </c:strCache>
            </c:strRef>
          </c:cat>
          <c:val>
            <c:numRef>
              <c:f>'250110Result'!$X$99:$Y$99</c:f>
              <c:numCache>
                <c:formatCode>0.000</c:formatCode>
                <c:ptCount val="2"/>
                <c:pt idx="0">
                  <c:v>1</c:v>
                </c:pt>
                <c:pt idx="1">
                  <c:v>1.14860965924961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DA1-314D-8703-7371D734D0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73156160"/>
        <c:axId val="1072859888"/>
      </c:barChart>
      <c:catAx>
        <c:axId val="1073156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2859888"/>
        <c:crosses val="autoZero"/>
        <c:auto val="1"/>
        <c:lblAlgn val="ctr"/>
        <c:lblOffset val="100"/>
        <c:noMultiLvlLbl val="0"/>
      </c:catAx>
      <c:valAx>
        <c:axId val="1072859888"/>
        <c:scaling>
          <c:orientation val="minMax"/>
          <c:max val="1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HK II/GAPDH</a:t>
                </a:r>
              </a:p>
              <a:p>
                <a:pPr>
                  <a:defRPr lang="ja-JP"/>
                </a:pPr>
                <a:r>
                  <a:rPr lang="en-US" dirty="0"/>
                  <a:t>(Relati</a:t>
                </a:r>
                <a:r>
                  <a:rPr lang="en-US" sz="800" b="0" i="0" u="none" strike="noStrike" kern="1200" baseline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r>
                  <a:rPr lang="en-US" dirty="0"/>
                  <a:t>e 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JP"/>
            </a:p>
          </c:txPr>
        </c:title>
        <c:numFmt formatCode="0.0;\-0.0;0;@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31561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2D4-5646-8EEE-92EE52BCDBBD}"/>
              </c:ext>
            </c:extLst>
          </c:dPt>
          <c:errBars>
            <c:errBarType val="both"/>
            <c:errValType val="cust"/>
            <c:noEndCap val="0"/>
            <c:plus>
              <c:numRef>
                <c:f>'250110Result'!$X$153:$Y$153</c:f>
                <c:numCache>
                  <c:formatCode>General</c:formatCode>
                  <c:ptCount val="2"/>
                  <c:pt idx="0">
                    <c:v>7.2764966888166124E-2</c:v>
                  </c:pt>
                  <c:pt idx="1">
                    <c:v>0.11427558890953166</c:v>
                  </c:pt>
                </c:numCache>
              </c:numRef>
            </c:plus>
            <c:minus>
              <c:numRef>
                <c:f>'250110Result'!$X$153:$Y$153</c:f>
                <c:numCache>
                  <c:formatCode>General</c:formatCode>
                  <c:ptCount val="2"/>
                  <c:pt idx="0">
                    <c:v>7.2764966888166124E-2</c:v>
                  </c:pt>
                  <c:pt idx="1">
                    <c:v>0.1142755889095316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50110Result'!$X$3:$Y$3</c:f>
              <c:strCache>
                <c:ptCount val="2"/>
                <c:pt idx="0">
                  <c:v>WT</c:v>
                </c:pt>
                <c:pt idx="1">
                  <c:v>Rspo3 mKO</c:v>
                </c:pt>
              </c:strCache>
            </c:strRef>
          </c:cat>
          <c:val>
            <c:numRef>
              <c:f>'250110Result'!$X$152:$Y$152</c:f>
              <c:numCache>
                <c:formatCode>0.000</c:formatCode>
                <c:ptCount val="2"/>
                <c:pt idx="0">
                  <c:v>0.99999999999999967</c:v>
                </c:pt>
                <c:pt idx="1">
                  <c:v>1.07230477255174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2D4-5646-8EEE-92EE52BCDB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73156160"/>
        <c:axId val="1072859888"/>
      </c:barChart>
      <c:catAx>
        <c:axId val="1073156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2859888"/>
        <c:crosses val="autoZero"/>
        <c:auto val="1"/>
        <c:lblAlgn val="ctr"/>
        <c:lblOffset val="100"/>
        <c:noMultiLvlLbl val="0"/>
      </c:catAx>
      <c:valAx>
        <c:axId val="1072859888"/>
        <c:scaling>
          <c:orientation val="minMax"/>
          <c:max val="1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Myoglobin/GAPDH</a:t>
                </a:r>
              </a:p>
              <a:p>
                <a:pPr>
                  <a:defRPr lang="ja-JP"/>
                </a:pPr>
                <a:r>
                  <a:rPr lang="en-US" dirty="0"/>
                  <a:t>(</a:t>
                </a:r>
                <a:r>
                  <a:rPr lang="en-US" sz="1100" b="0" i="0" u="none" strike="noStrike" kern="1200" baseline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dirty="0"/>
                  <a:t> 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JP"/>
            </a:p>
          </c:txPr>
        </c:title>
        <c:numFmt formatCode="0.0;\-0.0;0;@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31561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37A-9044-873D-678CAE8E10A8}"/>
              </c:ext>
            </c:extLst>
          </c:dPt>
          <c:errBars>
            <c:errBarType val="both"/>
            <c:errValType val="cust"/>
            <c:noEndCap val="0"/>
            <c:plus>
              <c:numRef>
                <c:f>'250110Result'!$X$179:$Y$179</c:f>
                <c:numCache>
                  <c:formatCode>General</c:formatCode>
                  <c:ptCount val="2"/>
                  <c:pt idx="0">
                    <c:v>4.9208981461841446E-2</c:v>
                  </c:pt>
                  <c:pt idx="1">
                    <c:v>9.5479958138423485E-2</c:v>
                  </c:pt>
                </c:numCache>
              </c:numRef>
            </c:plus>
            <c:minus>
              <c:numRef>
                <c:f>'250110Result'!$X$179:$Y$179</c:f>
                <c:numCache>
                  <c:formatCode>General</c:formatCode>
                  <c:ptCount val="2"/>
                  <c:pt idx="0">
                    <c:v>4.9208981461841446E-2</c:v>
                  </c:pt>
                  <c:pt idx="1">
                    <c:v>9.5479958138423485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50110Result'!$X$3:$Y$3</c:f>
              <c:strCache>
                <c:ptCount val="2"/>
                <c:pt idx="0">
                  <c:v>WT</c:v>
                </c:pt>
                <c:pt idx="1">
                  <c:v>Rspo3 mKO</c:v>
                </c:pt>
              </c:strCache>
            </c:strRef>
          </c:cat>
          <c:val>
            <c:numRef>
              <c:f>'250110Result'!$X$178:$Y$178</c:f>
              <c:numCache>
                <c:formatCode>0.000</c:formatCode>
                <c:ptCount val="2"/>
                <c:pt idx="0">
                  <c:v>1</c:v>
                </c:pt>
                <c:pt idx="1">
                  <c:v>1.09857196593209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37A-9044-873D-678CAE8E10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73156160"/>
        <c:axId val="1072859888"/>
      </c:barChart>
      <c:catAx>
        <c:axId val="1073156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2859888"/>
        <c:crosses val="autoZero"/>
        <c:auto val="1"/>
        <c:lblAlgn val="ctr"/>
        <c:lblOffset val="100"/>
        <c:noMultiLvlLbl val="0"/>
      </c:catAx>
      <c:valAx>
        <c:axId val="1072859888"/>
        <c:scaling>
          <c:orientation val="minMax"/>
          <c:max val="1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COX IV/GAPDH</a:t>
                </a:r>
              </a:p>
              <a:p>
                <a:pPr>
                  <a:defRPr lang="ja-JP"/>
                </a:pPr>
                <a:r>
                  <a:rPr lang="en-US" dirty="0"/>
                  <a:t>(Relati</a:t>
                </a:r>
                <a:r>
                  <a:rPr lang="en-US" sz="800" b="0" i="0" u="none" strike="noStrike" kern="1200" baseline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r>
                  <a:rPr lang="en-US" dirty="0"/>
                  <a:t>e 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JP"/>
            </a:p>
          </c:txPr>
        </c:title>
        <c:numFmt formatCode="0.0;\-0.0;0;@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JP"/>
          </a:p>
        </c:txPr>
        <c:crossAx val="10731561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43273082530379"/>
          <c:y val="5.8597784181091794E-2"/>
          <c:w val="0.738799275723937"/>
          <c:h val="0.78775763888888883"/>
        </c:manualLayout>
      </c:layout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50426_mRNA'!$U$72,'250426_mRNA'!$W$72,'250426_mRNA'!$Y$72)</c:f>
                <c:numCache>
                  <c:formatCode>General</c:formatCode>
                  <c:ptCount val="3"/>
                  <c:pt idx="0">
                    <c:v>0.10265886294852314</c:v>
                  </c:pt>
                  <c:pt idx="1">
                    <c:v>5.1276513493859061E-2</c:v>
                  </c:pt>
                  <c:pt idx="2">
                    <c:v>6.7114928000884477E-2</c:v>
                  </c:pt>
                </c:numCache>
              </c:numRef>
            </c:plus>
            <c:minus>
              <c:numRef>
                <c:f>('250426_mRNA'!$U$72,'250426_mRNA'!$W$72,'250426_mRNA'!$Y$72)</c:f>
                <c:numCache>
                  <c:formatCode>General</c:formatCode>
                  <c:ptCount val="3"/>
                  <c:pt idx="0">
                    <c:v>0.10265886294852314</c:v>
                  </c:pt>
                  <c:pt idx="1">
                    <c:v>5.1276513493859061E-2</c:v>
                  </c:pt>
                  <c:pt idx="2">
                    <c:v>6.7114928000884477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U$67,Sheet1!$W$67)</c:f>
              <c:strCache>
                <c:ptCount val="2"/>
                <c:pt idx="0">
                  <c:v>Uninjured</c:v>
                </c:pt>
                <c:pt idx="1">
                  <c:v>PI Day7</c:v>
                </c:pt>
              </c:strCache>
            </c:strRef>
          </c:cat>
          <c:val>
            <c:numRef>
              <c:f>('250426_mRNA'!$U$71,'250426_mRNA'!$W$71)</c:f>
              <c:numCache>
                <c:formatCode>0.000</c:formatCode>
                <c:ptCount val="2"/>
                <c:pt idx="0">
                  <c:v>1.0000000000000002</c:v>
                </c:pt>
                <c:pt idx="1">
                  <c:v>0.69276246166421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9E-B449-BB82-6C6C6C6D38BC}"/>
            </c:ext>
          </c:extLst>
        </c:ser>
        <c:ser>
          <c:idx val="1"/>
          <c:order val="1"/>
          <c:tx>
            <c:v>Rspo3 mKO</c:v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50426_mRNA'!$V$72,'250426_mRNA'!$X$72,'250426_mRNA'!$Z$72)</c:f>
                <c:numCache>
                  <c:formatCode>General</c:formatCode>
                  <c:ptCount val="3"/>
                  <c:pt idx="0">
                    <c:v>0.11731630049386378</c:v>
                  </c:pt>
                  <c:pt idx="1">
                    <c:v>0.11704703242472753</c:v>
                  </c:pt>
                  <c:pt idx="2">
                    <c:v>0.1120509866317979</c:v>
                  </c:pt>
                </c:numCache>
              </c:numRef>
            </c:plus>
            <c:minus>
              <c:numRef>
                <c:f>('250426_mRNA'!$V$72,'250426_mRNA'!$X$72,'250426_mRNA'!$Z$72)</c:f>
                <c:numCache>
                  <c:formatCode>General</c:formatCode>
                  <c:ptCount val="3"/>
                  <c:pt idx="0">
                    <c:v>0.11731630049386378</c:v>
                  </c:pt>
                  <c:pt idx="1">
                    <c:v>0.11704703242472753</c:v>
                  </c:pt>
                  <c:pt idx="2">
                    <c:v>0.112050986631797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U$67,Sheet1!$W$67)</c:f>
              <c:strCache>
                <c:ptCount val="2"/>
                <c:pt idx="0">
                  <c:v>Uninjured</c:v>
                </c:pt>
                <c:pt idx="1">
                  <c:v>PI Day7</c:v>
                </c:pt>
              </c:strCache>
            </c:strRef>
          </c:cat>
          <c:val>
            <c:numRef>
              <c:f>('250426_mRNA'!$V$71,'250426_mRNA'!$X$71)</c:f>
              <c:numCache>
                <c:formatCode>0.000</c:formatCode>
                <c:ptCount val="2"/>
                <c:pt idx="0">
                  <c:v>1.2072585616690643</c:v>
                </c:pt>
                <c:pt idx="1">
                  <c:v>0.702034944125933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09E-B449-BB82-6C6C6C6D38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479323440"/>
        <c:axId val="1479396400"/>
      </c:barChart>
      <c:catAx>
        <c:axId val="1479323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en-JP"/>
          </a:p>
        </c:txPr>
        <c:crossAx val="1479396400"/>
        <c:crosses val="autoZero"/>
        <c:auto val="1"/>
        <c:lblAlgn val="ctr"/>
        <c:lblOffset val="100"/>
        <c:noMultiLvlLbl val="0"/>
      </c:catAx>
      <c:valAx>
        <c:axId val="1479396400"/>
        <c:scaling>
          <c:orientation val="minMax"/>
          <c:max val="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defRPr>
                </a:pPr>
                <a:r>
                  <a:rPr lang="en-US"/>
                  <a:t>Lgr4/Tbp</a:t>
                </a:r>
              </a:p>
              <a:p>
                <a:pPr>
                  <a:defRPr/>
                </a:pPr>
                <a:r>
                  <a:rPr lang="en-US"/>
                  <a:t>(relative 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defRPr>
              </a:pPr>
              <a:endParaRPr lang="en-JP"/>
            </a:p>
          </c:txPr>
        </c:title>
        <c:numFmt formatCode="0.0;\-0.0;0;@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en-JP"/>
          </a:p>
        </c:txPr>
        <c:crossAx val="147932344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35556190476190469"/>
          <c:y val="4.4097222222222225E-2"/>
          <c:w val="0.49046349206349205"/>
          <c:h val="0.140665972222222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en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43273082530379"/>
          <c:y val="5.8597784181091794E-2"/>
          <c:w val="0.738799275723937"/>
          <c:h val="0.80539652777777782"/>
        </c:manualLayout>
      </c:layout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50426_mRNA'!$U$81,'250426_mRNA'!$W$81,'250426_mRNA'!$Y$81)</c:f>
                <c:numCache>
                  <c:formatCode>General</c:formatCode>
                  <c:ptCount val="3"/>
                  <c:pt idx="0">
                    <c:v>0.13478137813954877</c:v>
                  </c:pt>
                  <c:pt idx="1">
                    <c:v>0.54128153899533304</c:v>
                  </c:pt>
                  <c:pt idx="2">
                    <c:v>0.59354331457464315</c:v>
                  </c:pt>
                </c:numCache>
              </c:numRef>
            </c:plus>
            <c:minus>
              <c:numRef>
                <c:f>('250426_mRNA'!$U$81,'250426_mRNA'!$W$81,'250426_mRNA'!$Y$81)</c:f>
                <c:numCache>
                  <c:formatCode>General</c:formatCode>
                  <c:ptCount val="3"/>
                  <c:pt idx="0">
                    <c:v>0.13478137813954877</c:v>
                  </c:pt>
                  <c:pt idx="1">
                    <c:v>0.54128153899533304</c:v>
                  </c:pt>
                  <c:pt idx="2">
                    <c:v>0.5935433145746431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U$76,Sheet1!$W$76)</c:f>
              <c:strCache>
                <c:ptCount val="2"/>
                <c:pt idx="0">
                  <c:v>Uninjured</c:v>
                </c:pt>
                <c:pt idx="1">
                  <c:v>PI Day7</c:v>
                </c:pt>
              </c:strCache>
            </c:strRef>
          </c:cat>
          <c:val>
            <c:numRef>
              <c:f>('250426_mRNA'!$U$80,'250426_mRNA'!$W$80)</c:f>
              <c:numCache>
                <c:formatCode>0.000</c:formatCode>
                <c:ptCount val="2"/>
                <c:pt idx="0">
                  <c:v>1</c:v>
                </c:pt>
                <c:pt idx="1">
                  <c:v>3.6715519891680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A2-5543-8398-E60BB1883977}"/>
            </c:ext>
          </c:extLst>
        </c:ser>
        <c:ser>
          <c:idx val="1"/>
          <c:order val="1"/>
          <c:tx>
            <c:v>Rspo3 mKO</c:v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50426_mRNA'!$V$81,'250426_mRNA'!$X$81,'250426_mRNA'!$Z$81)</c:f>
                <c:numCache>
                  <c:formatCode>General</c:formatCode>
                  <c:ptCount val="3"/>
                  <c:pt idx="0">
                    <c:v>0.17098986521664683</c:v>
                  </c:pt>
                  <c:pt idx="1">
                    <c:v>0.22977782799198621</c:v>
                  </c:pt>
                  <c:pt idx="2">
                    <c:v>0.76090405796935412</c:v>
                  </c:pt>
                </c:numCache>
              </c:numRef>
            </c:plus>
            <c:minus>
              <c:numRef>
                <c:f>('250426_mRNA'!$V$81,'250426_mRNA'!$X$81,'250426_mRNA'!$Z$81)</c:f>
                <c:numCache>
                  <c:formatCode>General</c:formatCode>
                  <c:ptCount val="3"/>
                  <c:pt idx="0">
                    <c:v>0.17098986521664683</c:v>
                  </c:pt>
                  <c:pt idx="1">
                    <c:v>0.22977782799198621</c:v>
                  </c:pt>
                  <c:pt idx="2">
                    <c:v>0.7609040579693541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U$76,Sheet1!$W$76)</c:f>
              <c:strCache>
                <c:ptCount val="2"/>
                <c:pt idx="0">
                  <c:v>Uninjured</c:v>
                </c:pt>
                <c:pt idx="1">
                  <c:v>PI Day7</c:v>
                </c:pt>
              </c:strCache>
            </c:strRef>
          </c:cat>
          <c:val>
            <c:numRef>
              <c:f>(Sheet1!$V$80,Sheet1!$X$80)</c:f>
              <c:numCache>
                <c:formatCode>0.000</c:formatCode>
                <c:ptCount val="2"/>
                <c:pt idx="0">
                  <c:v>0.89358015846784011</c:v>
                </c:pt>
                <c:pt idx="1">
                  <c:v>2.99123582183505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0A2-5543-8398-E60BB18839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479323440"/>
        <c:axId val="1479396400"/>
      </c:barChart>
      <c:catAx>
        <c:axId val="1479323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en-JP"/>
          </a:p>
        </c:txPr>
        <c:crossAx val="1479396400"/>
        <c:crosses val="autoZero"/>
        <c:auto val="1"/>
        <c:lblAlgn val="ctr"/>
        <c:lblOffset val="100"/>
        <c:noMultiLvlLbl val="0"/>
      </c:catAx>
      <c:valAx>
        <c:axId val="1479396400"/>
        <c:scaling>
          <c:orientation val="minMax"/>
          <c:max val="6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defRPr>
                </a:pPr>
                <a:r>
                  <a:rPr lang="en-US"/>
                  <a:t>Lgr5/Tbp</a:t>
                </a:r>
              </a:p>
              <a:p>
                <a:pPr>
                  <a:defRPr/>
                </a:pPr>
                <a:r>
                  <a:rPr lang="en-US"/>
                  <a:t>(relative 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defRPr>
              </a:pPr>
              <a:endParaRPr lang="en-JP"/>
            </a:p>
          </c:txPr>
        </c:title>
        <c:numFmt formatCode="0.0;\-0.0;0;@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en-JP"/>
          </a:p>
        </c:txPr>
        <c:crossAx val="147932344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35556190476190469"/>
          <c:y val="5.2916666666666667E-2"/>
          <c:w val="0.49046349206349205"/>
          <c:h val="0.140665972222222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en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43273082530379"/>
          <c:y val="5.8597784181091794E-2"/>
          <c:w val="0.738799275723937"/>
          <c:h val="0.78775763888888883"/>
        </c:manualLayout>
      </c:layout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50426_mRNA'!$U$90,'250426_mRNA'!$W$90,'250426_mRNA'!$Y$90)</c:f>
                <c:numCache>
                  <c:formatCode>General</c:formatCode>
                  <c:ptCount val="3"/>
                  <c:pt idx="0">
                    <c:v>0.17592442684229573</c:v>
                  </c:pt>
                  <c:pt idx="1">
                    <c:v>3.1451820308667257E-2</c:v>
                  </c:pt>
                  <c:pt idx="2">
                    <c:v>0.1040386731466163</c:v>
                  </c:pt>
                </c:numCache>
              </c:numRef>
            </c:plus>
            <c:minus>
              <c:numRef>
                <c:f>('250426_mRNA'!$U$90,'250426_mRNA'!$W$90,'250426_mRNA'!$Y$90)</c:f>
                <c:numCache>
                  <c:formatCode>General</c:formatCode>
                  <c:ptCount val="3"/>
                  <c:pt idx="0">
                    <c:v>0.17592442684229573</c:v>
                  </c:pt>
                  <c:pt idx="1">
                    <c:v>3.1451820308667257E-2</c:v>
                  </c:pt>
                  <c:pt idx="2">
                    <c:v>0.104038673146616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U$85,Sheet1!$W$85)</c:f>
              <c:strCache>
                <c:ptCount val="2"/>
                <c:pt idx="0">
                  <c:v>Uninjured</c:v>
                </c:pt>
                <c:pt idx="1">
                  <c:v>PI Day7</c:v>
                </c:pt>
              </c:strCache>
            </c:strRef>
          </c:cat>
          <c:val>
            <c:numRef>
              <c:f>(Sheet1!$U$89,Sheet1!$W$89)</c:f>
              <c:numCache>
                <c:formatCode>0.000</c:formatCode>
                <c:ptCount val="2"/>
                <c:pt idx="0">
                  <c:v>1</c:v>
                </c:pt>
                <c:pt idx="1">
                  <c:v>0.182900991041046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A1-EC4A-A01F-916E6E4F8BF1}"/>
            </c:ext>
          </c:extLst>
        </c:ser>
        <c:ser>
          <c:idx val="1"/>
          <c:order val="1"/>
          <c:tx>
            <c:v>Rspo3 mKO</c:v>
          </c:tx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250426_mRNA'!$V$90,'250426_mRNA'!$X$90,'250426_mRNA'!$Z$90)</c:f>
                <c:numCache>
                  <c:formatCode>General</c:formatCode>
                  <c:ptCount val="3"/>
                  <c:pt idx="0">
                    <c:v>0.10730349627216741</c:v>
                  </c:pt>
                  <c:pt idx="1">
                    <c:v>4.6731976411474405E-2</c:v>
                  </c:pt>
                  <c:pt idx="2">
                    <c:v>9.1577303086118778E-2</c:v>
                  </c:pt>
                </c:numCache>
              </c:numRef>
            </c:plus>
            <c:minus>
              <c:numRef>
                <c:f>('250426_mRNA'!$V$90,'250426_mRNA'!$X$90,'250426_mRNA'!$Z$90)</c:f>
                <c:numCache>
                  <c:formatCode>General</c:formatCode>
                  <c:ptCount val="3"/>
                  <c:pt idx="0">
                    <c:v>0.10730349627216741</c:v>
                  </c:pt>
                  <c:pt idx="1">
                    <c:v>4.6731976411474405E-2</c:v>
                  </c:pt>
                  <c:pt idx="2">
                    <c:v>9.1577303086118778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U$85,Sheet1!$W$85)</c:f>
              <c:strCache>
                <c:ptCount val="2"/>
                <c:pt idx="0">
                  <c:v>Uninjured</c:v>
                </c:pt>
                <c:pt idx="1">
                  <c:v>PI Day7</c:v>
                </c:pt>
              </c:strCache>
            </c:strRef>
          </c:cat>
          <c:val>
            <c:numRef>
              <c:f>(Sheet1!$V$89,Sheet1!$X$89)</c:f>
              <c:numCache>
                <c:formatCode>0.000</c:formatCode>
                <c:ptCount val="2"/>
                <c:pt idx="0">
                  <c:v>0.93693892161549963</c:v>
                </c:pt>
                <c:pt idx="1">
                  <c:v>0.231291353514691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7A1-EC4A-A01F-916E6E4F8B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479323440"/>
        <c:axId val="1479396400"/>
      </c:barChart>
      <c:catAx>
        <c:axId val="1479323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en-JP"/>
          </a:p>
        </c:txPr>
        <c:crossAx val="1479396400"/>
        <c:crosses val="autoZero"/>
        <c:auto val="1"/>
        <c:lblAlgn val="ctr"/>
        <c:lblOffset val="100"/>
        <c:noMultiLvlLbl val="0"/>
      </c:catAx>
      <c:valAx>
        <c:axId val="1479396400"/>
        <c:scaling>
          <c:orientation val="minMax"/>
          <c:max val="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defRPr>
                </a:pPr>
                <a:r>
                  <a:rPr lang="en-US"/>
                  <a:t>Lgr</a:t>
                </a:r>
                <a:r>
                  <a:rPr lang="en-US" altLang="zh-CN"/>
                  <a:t>6</a:t>
                </a:r>
                <a:r>
                  <a:rPr lang="en-US"/>
                  <a:t>/Tbp</a:t>
                </a:r>
              </a:p>
              <a:p>
                <a:pPr>
                  <a:defRPr/>
                </a:pPr>
                <a:r>
                  <a:rPr lang="en-US"/>
                  <a:t>(relative Valu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defRPr>
              </a:pPr>
              <a:endParaRPr lang="en-JP"/>
            </a:p>
          </c:txPr>
        </c:title>
        <c:numFmt formatCode="0.0;\-0.0;0;@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en-JP"/>
          </a:p>
        </c:txPr>
        <c:crossAx val="147932344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3555619047619048"/>
          <c:y val="5.2916666666666667E-2"/>
          <c:w val="0.49046349206349205"/>
          <c:h val="0.140665972222222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en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pPr>
      <a:endParaRPr lang="en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BDA704-7D18-8643-AB73-C65BFBCF07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F033CE-3CB4-6643-8023-00C731A027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2310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cale Bar= 100µM; Width=5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91B820-957B-2B4D-B1F8-42EEE50F591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914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7793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8856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0467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813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3946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862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2337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513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2244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8862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261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08143-57E6-FE43-A64A-DFF252A3FD1E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0432D-02E1-4E48-B789-F509B9C64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7284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13" Type="http://schemas.openxmlformats.org/officeDocument/2006/relationships/image" Target="../media/image5.jpeg"/><Relationship Id="rId18" Type="http://schemas.openxmlformats.org/officeDocument/2006/relationships/image" Target="../media/image10.jpg"/><Relationship Id="rId3" Type="http://schemas.openxmlformats.org/officeDocument/2006/relationships/image" Target="../media/image1.emf"/><Relationship Id="rId21" Type="http://schemas.openxmlformats.org/officeDocument/2006/relationships/image" Target="../media/image13.jpg"/><Relationship Id="rId7" Type="http://schemas.openxmlformats.org/officeDocument/2006/relationships/chart" Target="../charts/chart1.xml"/><Relationship Id="rId12" Type="http://schemas.openxmlformats.org/officeDocument/2006/relationships/chart" Target="../charts/chart6.xml"/><Relationship Id="rId17" Type="http://schemas.openxmlformats.org/officeDocument/2006/relationships/image" Target="../media/image9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jpeg"/><Relationship Id="rId20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chart" Target="../charts/chart5.xml"/><Relationship Id="rId5" Type="http://schemas.openxmlformats.org/officeDocument/2006/relationships/image" Target="../media/image3.emf"/><Relationship Id="rId15" Type="http://schemas.openxmlformats.org/officeDocument/2006/relationships/image" Target="../media/image7.jpeg"/><Relationship Id="rId10" Type="http://schemas.openxmlformats.org/officeDocument/2006/relationships/chart" Target="../charts/chart4.xml"/><Relationship Id="rId19" Type="http://schemas.openxmlformats.org/officeDocument/2006/relationships/image" Target="../media/image11.jpg"/><Relationship Id="rId4" Type="http://schemas.openxmlformats.org/officeDocument/2006/relationships/image" Target="../media/image2.emf"/><Relationship Id="rId9" Type="http://schemas.openxmlformats.org/officeDocument/2006/relationships/chart" Target="../charts/chart3.xml"/><Relationship Id="rId14" Type="http://schemas.openxmlformats.org/officeDocument/2006/relationships/image" Target="../media/image6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テキスト ボックス 7">
            <a:extLst>
              <a:ext uri="{FF2B5EF4-FFF2-40B4-BE49-F238E27FC236}">
                <a16:creationId xmlns:a16="http://schemas.microsoft.com/office/drawing/2014/main" id="{93110D83-A41A-F72A-089E-389EE308B05B}"/>
              </a:ext>
            </a:extLst>
          </p:cNvPr>
          <p:cNvSpPr txBox="1"/>
          <p:nvPr/>
        </p:nvSpPr>
        <p:spPr>
          <a:xfrm>
            <a:off x="117822" y="2655138"/>
            <a:ext cx="733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kumimoji="1"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(b)</a:t>
            </a:r>
            <a:endParaRPr lang="ja-JP" altLang="en-US"/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F188BE81-8701-9CD4-8394-B24827A03CFB}"/>
              </a:ext>
            </a:extLst>
          </p:cNvPr>
          <p:cNvGrpSpPr/>
          <p:nvPr/>
        </p:nvGrpSpPr>
        <p:grpSpPr>
          <a:xfrm>
            <a:off x="250988" y="544920"/>
            <a:ext cx="2409824" cy="2002274"/>
            <a:chOff x="132557" y="5323905"/>
            <a:chExt cx="2409824" cy="2002274"/>
          </a:xfrm>
        </p:grpSpPr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C2966D5A-BE5A-ACEF-7AF1-0BA971085F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2557" y="5323905"/>
              <a:ext cx="2409824" cy="1663498"/>
            </a:xfrm>
            <a:prstGeom prst="rect">
              <a:avLst/>
            </a:prstGeom>
          </p:spPr>
        </p:pic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2FF3A4E3-7D91-FA3D-19E0-3563B6D32E28}"/>
                </a:ext>
              </a:extLst>
            </p:cNvPr>
            <p:cNvGrpSpPr/>
            <p:nvPr/>
          </p:nvGrpSpPr>
          <p:grpSpPr>
            <a:xfrm>
              <a:off x="807955" y="6735078"/>
              <a:ext cx="1620429" cy="591101"/>
              <a:chOff x="2231620" y="6119208"/>
              <a:chExt cx="2143854" cy="782037"/>
            </a:xfrm>
          </p:grpSpPr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A7F7B016-3E5B-453B-3975-AAB298DD2CBA}"/>
                  </a:ext>
                </a:extLst>
              </p:cNvPr>
              <p:cNvGrpSpPr/>
              <p:nvPr/>
            </p:nvGrpSpPr>
            <p:grpSpPr>
              <a:xfrm>
                <a:off x="2231620" y="6119208"/>
                <a:ext cx="1041654" cy="782037"/>
                <a:chOff x="4907152" y="6710430"/>
                <a:chExt cx="1041654" cy="782037"/>
              </a:xfrm>
            </p:grpSpPr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023069A3-E270-8AF0-73AC-907ED15F7350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07152" y="6802762"/>
                  <a:ext cx="545465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A05D1D46-A29A-862C-9EE9-2EF01516710F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235133" y="6710430"/>
                  <a:ext cx="702364" cy="4886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spo3</a:t>
                  </a:r>
                </a:p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KO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121F3379-E7C3-24EA-C7DC-E1082A524785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22184" y="7187072"/>
                  <a:ext cx="1026622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rk</a:t>
                  </a:r>
                </a:p>
              </p:txBody>
            </p:sp>
            <p:cxnSp>
              <p:nvCxnSpPr>
                <p:cNvPr id="79" name="Straight Connector 78">
                  <a:extLst>
                    <a:ext uri="{FF2B5EF4-FFF2-40B4-BE49-F238E27FC236}">
                      <a16:creationId xmlns:a16="http://schemas.microsoft.com/office/drawing/2014/main" id="{DDF3028D-DDD0-34DF-05FA-A9ECAE1AB1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22184" y="7187072"/>
                  <a:ext cx="102662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1" name="Group 70">
                <a:extLst>
                  <a:ext uri="{FF2B5EF4-FFF2-40B4-BE49-F238E27FC236}">
                    <a16:creationId xmlns:a16="http://schemas.microsoft.com/office/drawing/2014/main" id="{A18E02F4-600C-02A4-9193-86C8AC7F5201}"/>
                  </a:ext>
                </a:extLst>
              </p:cNvPr>
              <p:cNvGrpSpPr/>
              <p:nvPr/>
            </p:nvGrpSpPr>
            <p:grpSpPr>
              <a:xfrm>
                <a:off x="3333820" y="6119208"/>
                <a:ext cx="1041654" cy="782037"/>
                <a:chOff x="4907152" y="6710430"/>
                <a:chExt cx="1041654" cy="782037"/>
              </a:xfrm>
            </p:grpSpPr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8894CDF5-C571-726A-0D0A-4413779BA80B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07152" y="6802762"/>
                  <a:ext cx="545465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8532C65F-03DC-B7A8-C97C-A42D7ADA2C64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235133" y="6710430"/>
                  <a:ext cx="702364" cy="4886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spo3</a:t>
                  </a:r>
                </a:p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KO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FE156F13-B2C1-20CF-AC96-7155E4689E85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22184" y="7187072"/>
                  <a:ext cx="1026622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ight</a:t>
                  </a:r>
                </a:p>
              </p:txBody>
            </p:sp>
            <p:cxnSp>
              <p:nvCxnSpPr>
                <p:cNvPr id="75" name="Straight Connector 74">
                  <a:extLst>
                    <a:ext uri="{FF2B5EF4-FFF2-40B4-BE49-F238E27FC236}">
                      <a16:creationId xmlns:a16="http://schemas.microsoft.com/office/drawing/2014/main" id="{9F7324A3-8396-B2EC-037A-CDD90236F2E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22184" y="7187072"/>
                  <a:ext cx="102662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29374D80-AEBC-E8E7-5681-16A1DF10B549}"/>
              </a:ext>
            </a:extLst>
          </p:cNvPr>
          <p:cNvGrpSpPr/>
          <p:nvPr/>
        </p:nvGrpSpPr>
        <p:grpSpPr>
          <a:xfrm>
            <a:off x="2489444" y="567456"/>
            <a:ext cx="2366680" cy="1996214"/>
            <a:chOff x="2667740" y="5329965"/>
            <a:chExt cx="2366680" cy="1996214"/>
          </a:xfrm>
        </p:grpSpPr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589B9B77-3A3E-4980-53DB-455F00B9CF1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667740" y="5329965"/>
              <a:ext cx="2366680" cy="1651378"/>
            </a:xfrm>
            <a:prstGeom prst="rect">
              <a:avLst/>
            </a:prstGeom>
          </p:spPr>
        </p:pic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A50E975B-5EF7-364C-0CF9-1574267A7597}"/>
                </a:ext>
              </a:extLst>
            </p:cNvPr>
            <p:cNvGrpSpPr/>
            <p:nvPr/>
          </p:nvGrpSpPr>
          <p:grpSpPr>
            <a:xfrm>
              <a:off x="3341748" y="6735078"/>
              <a:ext cx="1620429" cy="591101"/>
              <a:chOff x="2231620" y="6119208"/>
              <a:chExt cx="2143854" cy="782037"/>
            </a:xfrm>
          </p:grpSpPr>
          <p:grpSp>
            <p:nvGrpSpPr>
              <p:cNvPr id="83" name="Group 82">
                <a:extLst>
                  <a:ext uri="{FF2B5EF4-FFF2-40B4-BE49-F238E27FC236}">
                    <a16:creationId xmlns:a16="http://schemas.microsoft.com/office/drawing/2014/main" id="{BD840CFE-CAE7-9B8A-85C9-334450FFDB8C}"/>
                  </a:ext>
                </a:extLst>
              </p:cNvPr>
              <p:cNvGrpSpPr/>
              <p:nvPr/>
            </p:nvGrpSpPr>
            <p:grpSpPr>
              <a:xfrm>
                <a:off x="2231620" y="6119208"/>
                <a:ext cx="1041654" cy="782037"/>
                <a:chOff x="4907152" y="6710430"/>
                <a:chExt cx="1041654" cy="782037"/>
              </a:xfrm>
            </p:grpSpPr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F80511DA-8A6B-D4CD-26BC-EDB94085B81E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07152" y="6802762"/>
                  <a:ext cx="545465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3E6514EC-8EA1-91A9-8E3A-247744ADDDB0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235133" y="6710430"/>
                  <a:ext cx="702364" cy="4886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spo3</a:t>
                  </a:r>
                </a:p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KO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B6CE0A42-9BFD-A650-FC5A-39CD0F7F4151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22184" y="7187072"/>
                  <a:ext cx="1026622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rk</a:t>
                  </a:r>
                </a:p>
              </p:txBody>
            </p:sp>
            <p:cxnSp>
              <p:nvCxnSpPr>
                <p:cNvPr id="92" name="Straight Connector 91">
                  <a:extLst>
                    <a:ext uri="{FF2B5EF4-FFF2-40B4-BE49-F238E27FC236}">
                      <a16:creationId xmlns:a16="http://schemas.microsoft.com/office/drawing/2014/main" id="{9E4A5F5C-99E1-DB75-C831-3E095B86167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22184" y="7187072"/>
                  <a:ext cx="102662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E4FA1A68-ECCC-3E7B-D4C0-D019729FB799}"/>
                  </a:ext>
                </a:extLst>
              </p:cNvPr>
              <p:cNvGrpSpPr/>
              <p:nvPr/>
            </p:nvGrpSpPr>
            <p:grpSpPr>
              <a:xfrm>
                <a:off x="3333820" y="6119208"/>
                <a:ext cx="1041654" cy="782037"/>
                <a:chOff x="4907152" y="6710430"/>
                <a:chExt cx="1041654" cy="782037"/>
              </a:xfrm>
            </p:grpSpPr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4CB56BD9-BCA1-FBD4-0DD0-3C9CF2579EA5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07152" y="6802762"/>
                  <a:ext cx="545465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4467D039-CE48-EB35-11AE-C98312ACDFAE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235133" y="6710430"/>
                  <a:ext cx="702364" cy="4886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spo3</a:t>
                  </a:r>
                </a:p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KO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07E4D54A-F7DF-0B74-46D4-EE351064B4B7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22184" y="7187072"/>
                  <a:ext cx="1026622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ight</a:t>
                  </a:r>
                </a:p>
              </p:txBody>
            </p:sp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id="{BC9FDCBC-BBCF-7C89-1F84-C6FC1CCB64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22184" y="7187072"/>
                  <a:ext cx="102662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062DA7BC-FB04-399B-C36A-26B8F891716E}"/>
              </a:ext>
            </a:extLst>
          </p:cNvPr>
          <p:cNvGrpSpPr/>
          <p:nvPr/>
        </p:nvGrpSpPr>
        <p:grpSpPr>
          <a:xfrm>
            <a:off x="4938200" y="569755"/>
            <a:ext cx="2371289" cy="1982439"/>
            <a:chOff x="4858539" y="5109249"/>
            <a:chExt cx="2371289" cy="1982439"/>
          </a:xfrm>
        </p:grpSpPr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314DCD7A-5ECE-379D-9822-C19E05F3960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858539" y="5109249"/>
              <a:ext cx="2371289" cy="1627527"/>
            </a:xfrm>
            <a:prstGeom prst="rect">
              <a:avLst/>
            </a:prstGeom>
          </p:spPr>
        </p:pic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B4C4670C-2A77-3572-C915-2952926154FD}"/>
                </a:ext>
              </a:extLst>
            </p:cNvPr>
            <p:cNvGrpSpPr/>
            <p:nvPr/>
          </p:nvGrpSpPr>
          <p:grpSpPr>
            <a:xfrm>
              <a:off x="5450314" y="6500587"/>
              <a:ext cx="1620429" cy="591101"/>
              <a:chOff x="2231620" y="6119208"/>
              <a:chExt cx="2143854" cy="782037"/>
            </a:xfrm>
          </p:grpSpPr>
          <p:grpSp>
            <p:nvGrpSpPr>
              <p:cNvPr id="96" name="Group 95">
                <a:extLst>
                  <a:ext uri="{FF2B5EF4-FFF2-40B4-BE49-F238E27FC236}">
                    <a16:creationId xmlns:a16="http://schemas.microsoft.com/office/drawing/2014/main" id="{09C6FFA9-D771-0174-3E23-8CBEF47E4C09}"/>
                  </a:ext>
                </a:extLst>
              </p:cNvPr>
              <p:cNvGrpSpPr/>
              <p:nvPr/>
            </p:nvGrpSpPr>
            <p:grpSpPr>
              <a:xfrm>
                <a:off x="2231620" y="6119208"/>
                <a:ext cx="1041654" cy="782037"/>
                <a:chOff x="4907152" y="6710430"/>
                <a:chExt cx="1041654" cy="782037"/>
              </a:xfrm>
            </p:grpSpPr>
            <p:sp>
              <p:nvSpPr>
                <p:cNvPr id="102" name="TextBox 101">
                  <a:extLst>
                    <a:ext uri="{FF2B5EF4-FFF2-40B4-BE49-F238E27FC236}">
                      <a16:creationId xmlns:a16="http://schemas.microsoft.com/office/drawing/2014/main" id="{F3EF6D35-AD4C-F2C1-B3EE-9CA6D863F76A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07152" y="6802762"/>
                  <a:ext cx="545465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1D0B76D1-C0B6-3879-BA27-5335C3A565A3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235133" y="6710430"/>
                  <a:ext cx="702364" cy="4886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spo3</a:t>
                  </a:r>
                </a:p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KO</a:t>
                  </a:r>
                </a:p>
              </p:txBody>
            </p:sp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D57EF60C-E3B4-92CA-6EF7-2411447A759C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22184" y="7187072"/>
                  <a:ext cx="1026622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rk</a:t>
                  </a:r>
                </a:p>
              </p:txBody>
            </p:sp>
            <p:cxnSp>
              <p:nvCxnSpPr>
                <p:cNvPr id="105" name="Straight Connector 104">
                  <a:extLst>
                    <a:ext uri="{FF2B5EF4-FFF2-40B4-BE49-F238E27FC236}">
                      <a16:creationId xmlns:a16="http://schemas.microsoft.com/office/drawing/2014/main" id="{FE9D1BA5-9062-915C-E15E-B03EBFC713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22184" y="7187072"/>
                  <a:ext cx="102662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873CC0F4-144F-024E-8826-60B4B6ED4AF0}"/>
                  </a:ext>
                </a:extLst>
              </p:cNvPr>
              <p:cNvGrpSpPr/>
              <p:nvPr/>
            </p:nvGrpSpPr>
            <p:grpSpPr>
              <a:xfrm>
                <a:off x="3333820" y="6119208"/>
                <a:ext cx="1041654" cy="782037"/>
                <a:chOff x="4907152" y="6710430"/>
                <a:chExt cx="1041654" cy="782037"/>
              </a:xfrm>
            </p:grpSpPr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749DF472-21E6-BFD4-DF7B-8A15E1CF6462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07152" y="6802762"/>
                  <a:ext cx="545465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99" name="TextBox 98">
                  <a:extLst>
                    <a:ext uri="{FF2B5EF4-FFF2-40B4-BE49-F238E27FC236}">
                      <a16:creationId xmlns:a16="http://schemas.microsoft.com/office/drawing/2014/main" id="{28599813-3FFC-7A50-06DA-3B3A7B95C5E6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235133" y="6710430"/>
                  <a:ext cx="702364" cy="4886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spo3</a:t>
                  </a:r>
                </a:p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KO</a:t>
                  </a:r>
                </a:p>
              </p:txBody>
            </p:sp>
            <p:sp>
              <p:nvSpPr>
                <p:cNvPr id="100" name="TextBox 99">
                  <a:extLst>
                    <a:ext uri="{FF2B5EF4-FFF2-40B4-BE49-F238E27FC236}">
                      <a16:creationId xmlns:a16="http://schemas.microsoft.com/office/drawing/2014/main" id="{84F309E6-0919-8CB0-1EA5-8E60C1F542DD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22184" y="7187072"/>
                  <a:ext cx="1026622" cy="3053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ight</a:t>
                  </a:r>
                </a:p>
              </p:txBody>
            </p:sp>
            <p:cxnSp>
              <p:nvCxnSpPr>
                <p:cNvPr id="101" name="Straight Connector 100">
                  <a:extLst>
                    <a:ext uri="{FF2B5EF4-FFF2-40B4-BE49-F238E27FC236}">
                      <a16:creationId xmlns:a16="http://schemas.microsoft.com/office/drawing/2014/main" id="{612BBA3E-82C8-53CA-4031-C9D04BD007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22184" y="7187072"/>
                  <a:ext cx="102662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pic>
        <p:nvPicPr>
          <p:cNvPr id="106" name="Picture 105">
            <a:extLst>
              <a:ext uri="{FF2B5EF4-FFF2-40B4-BE49-F238E27FC236}">
                <a16:creationId xmlns:a16="http://schemas.microsoft.com/office/drawing/2014/main" id="{C405870B-DE03-B547-F7BA-04F8BFC79D4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5759" y="3121671"/>
            <a:ext cx="3685409" cy="1951099"/>
          </a:xfrm>
          <a:prstGeom prst="rect">
            <a:avLst/>
          </a:prstGeom>
        </p:spPr>
      </p:pic>
      <p:sp>
        <p:nvSpPr>
          <p:cNvPr id="107" name="テキスト ボックス 7">
            <a:extLst>
              <a:ext uri="{FF2B5EF4-FFF2-40B4-BE49-F238E27FC236}">
                <a16:creationId xmlns:a16="http://schemas.microsoft.com/office/drawing/2014/main" id="{F7E7DCF9-8567-1CBC-37AC-91F333923DE6}"/>
              </a:ext>
            </a:extLst>
          </p:cNvPr>
          <p:cNvSpPr txBox="1"/>
          <p:nvPr/>
        </p:nvSpPr>
        <p:spPr>
          <a:xfrm>
            <a:off x="63050" y="237502"/>
            <a:ext cx="733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kumimoji="1"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(a)</a:t>
            </a:r>
            <a:endParaRPr lang="ja-JP" altLang="en-US"/>
          </a:p>
        </p:txBody>
      </p:sp>
      <p:sp>
        <p:nvSpPr>
          <p:cNvPr id="108" name="テキスト ボックス 11">
            <a:extLst>
              <a:ext uri="{FF2B5EF4-FFF2-40B4-BE49-F238E27FC236}">
                <a16:creationId xmlns:a16="http://schemas.microsoft.com/office/drawing/2014/main" id="{5F58E99E-988F-AE82-593A-5EC3C2EBB4AB}"/>
              </a:ext>
            </a:extLst>
          </p:cNvPr>
          <p:cNvSpPr txBox="1"/>
          <p:nvPr/>
        </p:nvSpPr>
        <p:spPr>
          <a:xfrm>
            <a:off x="0" y="-1918"/>
            <a:ext cx="7559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kumimoji="1" sz="1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JP" sz="1200">
                <a:ea typeface="Yu Mincho" panose="02020400000000000000" pitchFamily="18" charset="-128"/>
              </a:rPr>
              <a:t>Supplementary Figure </a:t>
            </a:r>
            <a:r>
              <a:rPr lang="en-JP" sz="1200" dirty="0">
                <a:ea typeface="Yu Mincho" panose="02020400000000000000" pitchFamily="18" charset="-128"/>
              </a:rPr>
              <a:t>1:</a:t>
            </a:r>
          </a:p>
        </p:txBody>
      </p:sp>
      <p:sp>
        <p:nvSpPr>
          <p:cNvPr id="109" name="テキスト ボックス 7">
            <a:extLst>
              <a:ext uri="{FF2B5EF4-FFF2-40B4-BE49-F238E27FC236}">
                <a16:creationId xmlns:a16="http://schemas.microsoft.com/office/drawing/2014/main" id="{788C5991-0DD8-8629-1EEA-E3CF8771B084}"/>
              </a:ext>
            </a:extLst>
          </p:cNvPr>
          <p:cNvSpPr txBox="1"/>
          <p:nvPr/>
        </p:nvSpPr>
        <p:spPr>
          <a:xfrm>
            <a:off x="122303" y="5339470"/>
            <a:ext cx="733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kumimoji="1"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(</a:t>
            </a:r>
            <a:r>
              <a:rPr lang="en-US" altLang="ja-JP"/>
              <a:t>c)</a:t>
            </a:r>
            <a:endParaRPr lang="ja-JP" altLang="en-US"/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4CEF75B4-C421-CD43-9998-35AB56E669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7421977"/>
              </p:ext>
            </p:extLst>
          </p:nvPr>
        </p:nvGraphicFramePr>
        <p:xfrm>
          <a:off x="563112" y="6037904"/>
          <a:ext cx="2146365" cy="1803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F5CED54-5449-1A47-A69E-EFF28C7E68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8265983"/>
              </p:ext>
            </p:extLst>
          </p:nvPr>
        </p:nvGraphicFramePr>
        <p:xfrm>
          <a:off x="2709323" y="6040130"/>
          <a:ext cx="2146211" cy="18008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0400017-7481-254F-8B8A-E2D3A4C93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2237962"/>
              </p:ext>
            </p:extLst>
          </p:nvPr>
        </p:nvGraphicFramePr>
        <p:xfrm>
          <a:off x="4855534" y="6037905"/>
          <a:ext cx="2145024" cy="18008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B3E7F3B2-EAD3-DB4D-8DCF-AF884C5817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6508506"/>
              </p:ext>
            </p:extLst>
          </p:nvPr>
        </p:nvGraphicFramePr>
        <p:xfrm>
          <a:off x="559116" y="8434109"/>
          <a:ext cx="2146211" cy="18018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EE29A7E5-5CA7-2C4F-A6B1-642824101F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7103469"/>
              </p:ext>
            </p:extLst>
          </p:nvPr>
        </p:nvGraphicFramePr>
        <p:xfrm>
          <a:off x="4855534" y="8434110"/>
          <a:ext cx="2145024" cy="18008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A28A537F-27F6-6C4E-B967-B13437E576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2678266"/>
              </p:ext>
            </p:extLst>
          </p:nvPr>
        </p:nvGraphicFramePr>
        <p:xfrm>
          <a:off x="2706514" y="8434110"/>
          <a:ext cx="2145024" cy="18008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pic>
        <p:nvPicPr>
          <p:cNvPr id="13" name="Picture 12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859769D1-2DD0-C6C5-FB4D-4D4D4BBD8DC5}"/>
              </a:ext>
            </a:extLst>
          </p:cNvPr>
          <p:cNvPicPr>
            <a:picLocks noChangeAspect="1"/>
          </p:cNvPicPr>
          <p:nvPr/>
        </p:nvPicPr>
        <p:blipFill>
          <a:blip r:embed="rId1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61584" y="5500449"/>
            <a:ext cx="686985" cy="3077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 descr="A close-up of a test&#10;&#10;Description automatically generated">
            <a:extLst>
              <a:ext uri="{FF2B5EF4-FFF2-40B4-BE49-F238E27FC236}">
                <a16:creationId xmlns:a16="http://schemas.microsoft.com/office/drawing/2014/main" id="{4965BF89-28BB-0C97-2D8E-A992F573635F}"/>
              </a:ext>
            </a:extLst>
          </p:cNvPr>
          <p:cNvPicPr>
            <a:picLocks noChangeAspect="1"/>
          </p:cNvPicPr>
          <p:nvPr/>
        </p:nvPicPr>
        <p:blipFill>
          <a:blip r:embed="rId1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64060" y="5852283"/>
            <a:ext cx="692006" cy="3077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A close-up of a test&#10;&#10;Description automatically generated">
            <a:extLst>
              <a:ext uri="{FF2B5EF4-FFF2-40B4-BE49-F238E27FC236}">
                <a16:creationId xmlns:a16="http://schemas.microsoft.com/office/drawing/2014/main" id="{2163652C-0AD2-4A76-C8C5-29F08C4B6D41}"/>
              </a:ext>
            </a:extLst>
          </p:cNvPr>
          <p:cNvPicPr>
            <a:picLocks noChangeAspect="1"/>
          </p:cNvPicPr>
          <p:nvPr/>
        </p:nvPicPr>
        <p:blipFill>
          <a:blip r:embed="rId1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45512" y="5500449"/>
            <a:ext cx="686985" cy="3077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A close-up of a test&#10;&#10;Description automatically generated">
            <a:extLst>
              <a:ext uri="{FF2B5EF4-FFF2-40B4-BE49-F238E27FC236}">
                <a16:creationId xmlns:a16="http://schemas.microsoft.com/office/drawing/2014/main" id="{D58AFB5F-78C8-CEBC-8888-64F674E9E672}"/>
              </a:ext>
            </a:extLst>
          </p:cNvPr>
          <p:cNvPicPr>
            <a:picLocks noChangeAspect="1"/>
          </p:cNvPicPr>
          <p:nvPr/>
        </p:nvPicPr>
        <p:blipFill>
          <a:blip r:embed="rId1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40897" y="5852283"/>
            <a:ext cx="692007" cy="3077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 descr="A close-up of a test&#10;&#10;Description automatically generated">
            <a:extLst>
              <a:ext uri="{FF2B5EF4-FFF2-40B4-BE49-F238E27FC236}">
                <a16:creationId xmlns:a16="http://schemas.microsoft.com/office/drawing/2014/main" id="{52DEB216-3234-44FD-C94E-DAB5B295B6C3}"/>
              </a:ext>
            </a:extLst>
          </p:cNvPr>
          <p:cNvPicPr>
            <a:picLocks noChangeAspect="1"/>
          </p:cNvPicPr>
          <p:nvPr/>
        </p:nvPicPr>
        <p:blipFill>
          <a:blip r:embed="rId1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91568" y="5506344"/>
            <a:ext cx="686986" cy="3077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A9EC927-062A-2A49-368A-2139E8AD729E}"/>
              </a:ext>
            </a:extLst>
          </p:cNvPr>
          <p:cNvSpPr txBox="1"/>
          <p:nvPr/>
        </p:nvSpPr>
        <p:spPr>
          <a:xfrm>
            <a:off x="926386" y="5518602"/>
            <a:ext cx="72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MyHC 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C6A9F87-EE4D-8EFA-1662-7F5005025CD0}"/>
              </a:ext>
            </a:extLst>
          </p:cNvPr>
          <p:cNvSpPr txBox="1"/>
          <p:nvPr/>
        </p:nvSpPr>
        <p:spPr>
          <a:xfrm>
            <a:off x="933099" y="5878078"/>
            <a:ext cx="72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122EE2-BC50-575C-1A1F-F79ADA3C3835}"/>
              </a:ext>
            </a:extLst>
          </p:cNvPr>
          <p:cNvSpPr txBox="1"/>
          <p:nvPr/>
        </p:nvSpPr>
        <p:spPr>
          <a:xfrm>
            <a:off x="3009033" y="5517533"/>
            <a:ext cx="72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MyHC I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612C881-F8B3-68E9-0BAB-DA02CB191084}"/>
              </a:ext>
            </a:extLst>
          </p:cNvPr>
          <p:cNvSpPr txBox="1"/>
          <p:nvPr/>
        </p:nvSpPr>
        <p:spPr>
          <a:xfrm>
            <a:off x="3015746" y="5877009"/>
            <a:ext cx="72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72E76F2-1C1C-F92A-2DB4-86085C09E506}"/>
              </a:ext>
            </a:extLst>
          </p:cNvPr>
          <p:cNvSpPr txBox="1"/>
          <p:nvPr/>
        </p:nvSpPr>
        <p:spPr>
          <a:xfrm>
            <a:off x="5150971" y="5508747"/>
            <a:ext cx="72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62C9639-044C-2233-EF97-89B2B2B66A17}"/>
              </a:ext>
            </a:extLst>
          </p:cNvPr>
          <p:cNvSpPr txBox="1"/>
          <p:nvPr/>
        </p:nvSpPr>
        <p:spPr>
          <a:xfrm>
            <a:off x="5157684" y="5868223"/>
            <a:ext cx="72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679861-A340-9F51-3E78-63ACFE13A3D6}"/>
              </a:ext>
            </a:extLst>
          </p:cNvPr>
          <p:cNvSpPr txBox="1"/>
          <p:nvPr/>
        </p:nvSpPr>
        <p:spPr>
          <a:xfrm>
            <a:off x="4938200" y="7859536"/>
            <a:ext cx="9249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yoglobin</a:t>
            </a:r>
            <a:endParaRPr lang="en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9D8D3D6-DE8D-FCD5-254F-6574D902DB1C}"/>
              </a:ext>
            </a:extLst>
          </p:cNvPr>
          <p:cNvSpPr txBox="1"/>
          <p:nvPr/>
        </p:nvSpPr>
        <p:spPr>
          <a:xfrm>
            <a:off x="5141371" y="8219012"/>
            <a:ext cx="72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D55B14B-32B4-50F0-E47F-B9B4CC5AFA50}"/>
              </a:ext>
            </a:extLst>
          </p:cNvPr>
          <p:cNvSpPr txBox="1"/>
          <p:nvPr/>
        </p:nvSpPr>
        <p:spPr>
          <a:xfrm>
            <a:off x="2853763" y="7863407"/>
            <a:ext cx="924943" cy="246221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X IV</a:t>
            </a:r>
            <a:endParaRPr lang="en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520783F-0422-C0EF-3B53-E8200D5F3BB4}"/>
              </a:ext>
            </a:extLst>
          </p:cNvPr>
          <p:cNvSpPr txBox="1"/>
          <p:nvPr/>
        </p:nvSpPr>
        <p:spPr>
          <a:xfrm>
            <a:off x="3056934" y="8222883"/>
            <a:ext cx="72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36899CA-7E9E-0CA7-AE7E-FDE08E479B70}"/>
              </a:ext>
            </a:extLst>
          </p:cNvPr>
          <p:cNvSpPr txBox="1"/>
          <p:nvPr/>
        </p:nvSpPr>
        <p:spPr>
          <a:xfrm>
            <a:off x="714381" y="7889222"/>
            <a:ext cx="9249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K II</a:t>
            </a:r>
            <a:endParaRPr lang="en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7C586DD-45C3-880F-874C-A08D76E9B942}"/>
              </a:ext>
            </a:extLst>
          </p:cNvPr>
          <p:cNvSpPr txBox="1"/>
          <p:nvPr/>
        </p:nvSpPr>
        <p:spPr>
          <a:xfrm>
            <a:off x="917552" y="8248698"/>
            <a:ext cx="7284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JP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28" name="Picture 27" descr="A blurry image of a dna test&#10;&#10;Description automatically generated">
            <a:extLst>
              <a:ext uri="{FF2B5EF4-FFF2-40B4-BE49-F238E27FC236}">
                <a16:creationId xmlns:a16="http://schemas.microsoft.com/office/drawing/2014/main" id="{B238C4D9-7446-5383-02E6-E6577E638A69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8039" t="46292" r="77765" b="49252"/>
          <a:stretch/>
        </p:blipFill>
        <p:spPr>
          <a:xfrm>
            <a:off x="1646037" y="7870251"/>
            <a:ext cx="713957" cy="307777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9" name="Picture 28" descr="A close-up of a line&#10;&#10;Description automatically generated">
            <a:extLst>
              <a:ext uri="{FF2B5EF4-FFF2-40B4-BE49-F238E27FC236}">
                <a16:creationId xmlns:a16="http://schemas.microsoft.com/office/drawing/2014/main" id="{3078DC42-BF7E-1B5A-EB40-EBC25AD9E631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5656" t="26310" r="79808" b="69100"/>
          <a:stretch/>
        </p:blipFill>
        <p:spPr>
          <a:xfrm>
            <a:off x="1652750" y="8222643"/>
            <a:ext cx="709781" cy="30777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32" name="Picture 31" descr="A close-up of a line&#10;&#10;Description automatically generated">
            <a:extLst>
              <a:ext uri="{FF2B5EF4-FFF2-40B4-BE49-F238E27FC236}">
                <a16:creationId xmlns:a16="http://schemas.microsoft.com/office/drawing/2014/main" id="{585B2458-BECE-8E93-A3DA-BFD04281E022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11262" t="39052" r="75064" b="56647"/>
          <a:stretch/>
        </p:blipFill>
        <p:spPr>
          <a:xfrm>
            <a:off x="3789926" y="8222643"/>
            <a:ext cx="713488" cy="30777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4CD0AA6-AEC6-495A-6E01-61FBFC20FB4D}"/>
              </a:ext>
            </a:extLst>
          </p:cNvPr>
          <p:cNvCxnSpPr/>
          <p:nvPr/>
        </p:nvCxnSpPr>
        <p:spPr>
          <a:xfrm>
            <a:off x="2352129" y="5624653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A08C056-E014-86F7-CDAA-CC7EFDE9C583}"/>
              </a:ext>
            </a:extLst>
          </p:cNvPr>
          <p:cNvSpPr txBox="1"/>
          <p:nvPr/>
        </p:nvSpPr>
        <p:spPr>
          <a:xfrm>
            <a:off x="2481403" y="5519410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250kDa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9F69A23-866F-FCE3-7C53-B67D243B52CD}"/>
              </a:ext>
            </a:extLst>
          </p:cNvPr>
          <p:cNvCxnSpPr/>
          <p:nvPr/>
        </p:nvCxnSpPr>
        <p:spPr>
          <a:xfrm>
            <a:off x="2354991" y="6008751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F5B02ED1-3575-A012-E7B5-629674DDEF5E}"/>
              </a:ext>
            </a:extLst>
          </p:cNvPr>
          <p:cNvSpPr txBox="1"/>
          <p:nvPr/>
        </p:nvSpPr>
        <p:spPr>
          <a:xfrm>
            <a:off x="2484265" y="5903508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8EF9E103-9077-AC08-FBAF-3E5C1AA84C71}"/>
              </a:ext>
            </a:extLst>
          </p:cNvPr>
          <p:cNvCxnSpPr/>
          <p:nvPr/>
        </p:nvCxnSpPr>
        <p:spPr>
          <a:xfrm>
            <a:off x="4437838" y="5676368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8CF60280-7DB3-5DB5-4374-196DBAFB468A}"/>
              </a:ext>
            </a:extLst>
          </p:cNvPr>
          <p:cNvSpPr txBox="1"/>
          <p:nvPr/>
        </p:nvSpPr>
        <p:spPr>
          <a:xfrm>
            <a:off x="4567112" y="5571125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250kDa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F8679B8-5FAF-C93E-08D2-83E22A149FC2}"/>
              </a:ext>
            </a:extLst>
          </p:cNvPr>
          <p:cNvCxnSpPr/>
          <p:nvPr/>
        </p:nvCxnSpPr>
        <p:spPr>
          <a:xfrm>
            <a:off x="4438106" y="6007978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6A5DDC7F-CEC6-E6DF-58C7-1CE42BD2470C}"/>
              </a:ext>
            </a:extLst>
          </p:cNvPr>
          <p:cNvSpPr txBox="1"/>
          <p:nvPr/>
        </p:nvSpPr>
        <p:spPr>
          <a:xfrm>
            <a:off x="4567380" y="5902735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8BF08878-44C3-E763-6F4C-5A41565BAA4A}"/>
              </a:ext>
            </a:extLst>
          </p:cNvPr>
          <p:cNvCxnSpPr/>
          <p:nvPr/>
        </p:nvCxnSpPr>
        <p:spPr>
          <a:xfrm>
            <a:off x="6588465" y="5690666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24CCEEFD-C3F7-C921-9E12-D926AFC31F5F}"/>
              </a:ext>
            </a:extLst>
          </p:cNvPr>
          <p:cNvSpPr txBox="1"/>
          <p:nvPr/>
        </p:nvSpPr>
        <p:spPr>
          <a:xfrm>
            <a:off x="6717739" y="5585423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100kDa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7567DF1F-E327-E2A1-5FF9-7945EF25A82F}"/>
              </a:ext>
            </a:extLst>
          </p:cNvPr>
          <p:cNvCxnSpPr/>
          <p:nvPr/>
        </p:nvCxnSpPr>
        <p:spPr>
          <a:xfrm>
            <a:off x="6588592" y="5999144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B337A026-CD9F-8D29-59C1-983400050365}"/>
              </a:ext>
            </a:extLst>
          </p:cNvPr>
          <p:cNvSpPr txBox="1"/>
          <p:nvPr/>
        </p:nvSpPr>
        <p:spPr>
          <a:xfrm>
            <a:off x="6717866" y="5893901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3E4E7557-DD59-36A2-B14D-05898BE7DBFE}"/>
              </a:ext>
            </a:extLst>
          </p:cNvPr>
          <p:cNvCxnSpPr/>
          <p:nvPr/>
        </p:nvCxnSpPr>
        <p:spPr>
          <a:xfrm>
            <a:off x="6587216" y="8063457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0CBD81D9-67BE-7E4C-C8B4-934A8C1533D8}"/>
              </a:ext>
            </a:extLst>
          </p:cNvPr>
          <p:cNvSpPr txBox="1"/>
          <p:nvPr/>
        </p:nvSpPr>
        <p:spPr>
          <a:xfrm>
            <a:off x="6716490" y="7958214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15kDa</a:t>
            </a:r>
            <a:endParaRPr lang="en-JP" sz="800" dirty="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38CC314D-EACD-0E91-B9E6-0BF00726FF56}"/>
              </a:ext>
            </a:extLst>
          </p:cNvPr>
          <p:cNvCxnSpPr/>
          <p:nvPr/>
        </p:nvCxnSpPr>
        <p:spPr>
          <a:xfrm>
            <a:off x="6587343" y="8363740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32CA399E-250E-D8BE-1A61-E063BD693629}"/>
              </a:ext>
            </a:extLst>
          </p:cNvPr>
          <p:cNvSpPr txBox="1"/>
          <p:nvPr/>
        </p:nvSpPr>
        <p:spPr>
          <a:xfrm>
            <a:off x="6716617" y="8258497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73CE9B5-10CD-ECB4-F8FD-7DE05B713B8D}"/>
              </a:ext>
            </a:extLst>
          </p:cNvPr>
          <p:cNvCxnSpPr/>
          <p:nvPr/>
        </p:nvCxnSpPr>
        <p:spPr>
          <a:xfrm>
            <a:off x="4501820" y="8078949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ED7C8B41-B612-0376-6352-AAF7C3811CCA}"/>
              </a:ext>
            </a:extLst>
          </p:cNvPr>
          <p:cNvSpPr txBox="1"/>
          <p:nvPr/>
        </p:nvSpPr>
        <p:spPr>
          <a:xfrm>
            <a:off x="4631094" y="7973706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15kDa</a:t>
            </a:r>
            <a:endParaRPr lang="en-JP" sz="800" dirty="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B78FCF07-11C4-78F5-CA17-82437DA4E2D2}"/>
              </a:ext>
            </a:extLst>
          </p:cNvPr>
          <p:cNvCxnSpPr/>
          <p:nvPr/>
        </p:nvCxnSpPr>
        <p:spPr>
          <a:xfrm>
            <a:off x="4501820" y="8355110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69720F12-8AB5-63AD-582F-52607121D391}"/>
              </a:ext>
            </a:extLst>
          </p:cNvPr>
          <p:cNvSpPr txBox="1"/>
          <p:nvPr/>
        </p:nvSpPr>
        <p:spPr>
          <a:xfrm>
            <a:off x="4631094" y="8249867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D29B25D3-EB82-FB72-95B1-F9C9B2A10842}"/>
              </a:ext>
            </a:extLst>
          </p:cNvPr>
          <p:cNvCxnSpPr/>
          <p:nvPr/>
        </p:nvCxnSpPr>
        <p:spPr>
          <a:xfrm>
            <a:off x="2364784" y="8128058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E795148C-204D-564C-C342-95E88AD77A3B}"/>
              </a:ext>
            </a:extLst>
          </p:cNvPr>
          <p:cNvSpPr txBox="1"/>
          <p:nvPr/>
        </p:nvSpPr>
        <p:spPr>
          <a:xfrm>
            <a:off x="2494058" y="8022815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100kDa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977D61DB-5E56-1302-DFA1-EDEB7B6687B9}"/>
              </a:ext>
            </a:extLst>
          </p:cNvPr>
          <p:cNvCxnSpPr/>
          <p:nvPr/>
        </p:nvCxnSpPr>
        <p:spPr>
          <a:xfrm>
            <a:off x="2364911" y="8341286"/>
            <a:ext cx="1337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EA6E731F-0727-0AD9-12C4-9C2A6B3DFF69}"/>
              </a:ext>
            </a:extLst>
          </p:cNvPr>
          <p:cNvSpPr txBox="1"/>
          <p:nvPr/>
        </p:nvSpPr>
        <p:spPr>
          <a:xfrm>
            <a:off x="2494185" y="8236043"/>
            <a:ext cx="5656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8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37kDa</a:t>
            </a:r>
          </a:p>
        </p:txBody>
      </p:sp>
      <p:pic>
        <p:nvPicPr>
          <p:cNvPr id="57" name="Picture 56" descr="A close-up of a line&#10;&#10;Description automatically generated">
            <a:extLst>
              <a:ext uri="{FF2B5EF4-FFF2-40B4-BE49-F238E27FC236}">
                <a16:creationId xmlns:a16="http://schemas.microsoft.com/office/drawing/2014/main" id="{B5F5693E-662E-2FF9-0663-8B22A054FCB8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58993" t="26210" r="26868" b="69212"/>
          <a:stretch/>
        </p:blipFill>
        <p:spPr>
          <a:xfrm>
            <a:off x="5896872" y="5853460"/>
            <a:ext cx="686986" cy="305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Picture 58" descr="A close-up of a line&#10;&#10;Description automatically generated">
            <a:extLst>
              <a:ext uri="{FF2B5EF4-FFF2-40B4-BE49-F238E27FC236}">
                <a16:creationId xmlns:a16="http://schemas.microsoft.com/office/drawing/2014/main" id="{F9122CFB-853E-F05C-F6B5-7B9AC0DDC646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8458" t="50191" r="76515" b="44980"/>
          <a:stretch/>
        </p:blipFill>
        <p:spPr>
          <a:xfrm>
            <a:off x="3790927" y="7864306"/>
            <a:ext cx="712800" cy="31411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60" name="Picture 59" descr="Blur blurry black lines on a white background&#10;&#10;Description automatically generated">
            <a:extLst>
              <a:ext uri="{FF2B5EF4-FFF2-40B4-BE49-F238E27FC236}">
                <a16:creationId xmlns:a16="http://schemas.microsoft.com/office/drawing/2014/main" id="{91A9B9CB-4145-FD2D-EF39-76958F2B9DBB}"/>
              </a:ext>
            </a:extLst>
          </p:cNvPr>
          <p:cNvPicPr>
            <a:picLocks/>
          </p:cNvPicPr>
          <p:nvPr/>
        </p:nvPicPr>
        <p:blipFill rotWithShape="1">
          <a:blip r:embed="rId21"/>
          <a:srcRect l="7632" t="66747" r="75541" b="27731"/>
          <a:stretch/>
        </p:blipFill>
        <p:spPr>
          <a:xfrm>
            <a:off x="5865754" y="7868825"/>
            <a:ext cx="712800" cy="309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Picture 60" descr="A close-up of a line&#10;&#10;Description automatically generated">
            <a:extLst>
              <a:ext uri="{FF2B5EF4-FFF2-40B4-BE49-F238E27FC236}">
                <a16:creationId xmlns:a16="http://schemas.microsoft.com/office/drawing/2014/main" id="{45FA4F9B-5449-92C9-B48B-8DCB822DB562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9218" t="79293" r="76029" b="16073"/>
          <a:stretch/>
        </p:blipFill>
        <p:spPr>
          <a:xfrm>
            <a:off x="5865754" y="8222644"/>
            <a:ext cx="713489" cy="307777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6692968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0" name="Chart 69">
            <a:extLst>
              <a:ext uri="{FF2B5EF4-FFF2-40B4-BE49-F238E27FC236}">
                <a16:creationId xmlns:a16="http://schemas.microsoft.com/office/drawing/2014/main" id="{1E5B9B4E-D19B-8843-BA5D-AE79A4DEE2A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6050999"/>
              </p:ext>
            </p:extLst>
          </p:nvPr>
        </p:nvGraphicFramePr>
        <p:xfrm>
          <a:off x="763821" y="911478"/>
          <a:ext cx="252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1" name="Chart 70">
            <a:extLst>
              <a:ext uri="{FF2B5EF4-FFF2-40B4-BE49-F238E27FC236}">
                <a16:creationId xmlns:a16="http://schemas.microsoft.com/office/drawing/2014/main" id="{6335DD29-2620-EF4E-8D83-A9A8399D4D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7373406"/>
              </p:ext>
            </p:extLst>
          </p:nvPr>
        </p:nvGraphicFramePr>
        <p:xfrm>
          <a:off x="3283821" y="911478"/>
          <a:ext cx="252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2" name="Chart 71">
            <a:extLst>
              <a:ext uri="{FF2B5EF4-FFF2-40B4-BE49-F238E27FC236}">
                <a16:creationId xmlns:a16="http://schemas.microsoft.com/office/drawing/2014/main" id="{8537010B-444A-734B-BA95-27913941CB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3716522"/>
              </p:ext>
            </p:extLst>
          </p:nvPr>
        </p:nvGraphicFramePr>
        <p:xfrm>
          <a:off x="763821" y="2351478"/>
          <a:ext cx="252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3EABFB7B-6FEB-DDAD-8D95-3D43941BB9ED}"/>
              </a:ext>
            </a:extLst>
          </p:cNvPr>
          <p:cNvSpPr txBox="1"/>
          <p:nvPr/>
        </p:nvSpPr>
        <p:spPr>
          <a:xfrm>
            <a:off x="0" y="-1918"/>
            <a:ext cx="7559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kumimoji="1" sz="1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JP" sz="1200" dirty="0">
                <a:ea typeface="Yu Mincho" panose="02020400000000000000" pitchFamily="18" charset="-128"/>
              </a:rPr>
              <a:t>Supplementary Figure 2:</a:t>
            </a:r>
          </a:p>
        </p:txBody>
      </p:sp>
      <p:sp>
        <p:nvSpPr>
          <p:cNvPr id="2" name="テキスト ボックス 7">
            <a:extLst>
              <a:ext uri="{FF2B5EF4-FFF2-40B4-BE49-F238E27FC236}">
                <a16:creationId xmlns:a16="http://schemas.microsoft.com/office/drawing/2014/main" id="{F82CFDF9-B8F3-6232-4AE5-F317A44E2ABB}"/>
              </a:ext>
            </a:extLst>
          </p:cNvPr>
          <p:cNvSpPr txBox="1"/>
          <p:nvPr/>
        </p:nvSpPr>
        <p:spPr>
          <a:xfrm>
            <a:off x="63050" y="237502"/>
            <a:ext cx="733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kumimoji="1"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(a)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23335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3</TotalTime>
  <Words>150</Words>
  <Application>Microsoft Macintosh PowerPoint</Application>
  <PresentationFormat>Custom</PresentationFormat>
  <Paragraphs>74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游ゴシック</vt:lpstr>
      <vt:lpstr>Yu Mincho</vt:lpstr>
      <vt:lpstr>Arial</vt:lpstr>
      <vt:lpstr>Calibri</vt:lpstr>
      <vt:lpstr>Calibri Light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胡騰</dc:creator>
  <cp:lastModifiedBy>胡　騰</cp:lastModifiedBy>
  <cp:revision>805</cp:revision>
  <cp:lastPrinted>2024-05-13T03:59:09Z</cp:lastPrinted>
  <dcterms:created xsi:type="dcterms:W3CDTF">2022-11-16T06:05:58Z</dcterms:created>
  <dcterms:modified xsi:type="dcterms:W3CDTF">2025-08-28T02:47:06Z</dcterms:modified>
</cp:coreProperties>
</file>